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D829BC-6BF3-4F43-AACB-57721520D4A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24BF62-6354-4D5A-8372-8685E3D5F1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E42989-CE59-4986-B33F-7D87FE54158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1D72AB-8573-4446-A4E6-6ACCF85D070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4804A7-28C6-474E-81D0-1C5FD9A12A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79035D-ABC2-4C3D-B189-7E129F6223C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207538-330A-480F-B038-7A2509B9BC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F75CF1-EEBD-474D-A6DE-83F0A22E95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B591FF-268F-481C-AAA2-23AAAC99A6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234C53-99C0-4DCE-9CA6-1FE015EF8D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8B24FE-5F0A-4DCA-9E1F-7EDE04507E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7721DB-56E5-4C0F-8B4D-D9934924CC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D173F32-2BD0-45A4-BDA7-6DAA7EF9249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3.png"/><Relationship Id="rId5" Type="http://schemas.openxmlformats.org/officeDocument/2006/relationships/image" Target="../media/image3.png"/><Relationship Id="rId6" Type="http://schemas.openxmlformats.org/officeDocument/2006/relationships/image" Target="../media/image3.png"/><Relationship Id="rId7" Type="http://schemas.openxmlformats.org/officeDocument/2006/relationships/image" Target="../media/image1.pn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933720" y="4140360"/>
            <a:ext cx="2663280" cy="2662920"/>
            <a:chOff x="3933720" y="4140360"/>
            <a:chExt cx="2663280" cy="2662920"/>
          </a:xfrm>
        </p:grpSpPr>
        <p:grpSp>
          <p:nvGrpSpPr>
            <p:cNvPr id="42" name=""/>
            <p:cNvGrpSpPr/>
            <p:nvPr/>
          </p:nvGrpSpPr>
          <p:grpSpPr>
            <a:xfrm>
              <a:off x="4405680" y="4211280"/>
              <a:ext cx="2191320" cy="2176560"/>
              <a:chOff x="4405680" y="4211280"/>
              <a:chExt cx="2191320" cy="2176560"/>
            </a:xfrm>
          </p:grpSpPr>
          <p:sp>
            <p:nvSpPr>
              <p:cNvPr id="43" name=""/>
              <p:cNvSpPr/>
              <p:nvPr/>
            </p:nvSpPr>
            <p:spPr>
              <a:xfrm>
                <a:off x="4451760" y="4211280"/>
                <a:ext cx="2160" cy="2143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" name=""/>
              <p:cNvSpPr/>
              <p:nvPr/>
            </p:nvSpPr>
            <p:spPr>
              <a:xfrm>
                <a:off x="4405680" y="6354720"/>
                <a:ext cx="9288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4405680" y="5999400"/>
                <a:ext cx="928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4405680" y="5644080"/>
                <a:ext cx="928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4405680" y="5288400"/>
                <a:ext cx="9288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4405680" y="4921920"/>
                <a:ext cx="9288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4405680" y="4566600"/>
                <a:ext cx="928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4405680" y="4211280"/>
                <a:ext cx="928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4451760" y="6354720"/>
                <a:ext cx="214524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 flipV="1">
                <a:off x="4719960" y="6354360"/>
                <a:ext cx="1440" cy="334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320" bIns="-13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 flipV="1">
                <a:off x="5256360" y="6354360"/>
                <a:ext cx="2160" cy="334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320" bIns="-13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 flipV="1">
                <a:off x="5792400" y="6354360"/>
                <a:ext cx="2160" cy="334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320" bIns="-13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 flipV="1">
                <a:off x="6328800" y="6354360"/>
                <a:ext cx="2160" cy="334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320" bIns="-13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4719960" y="4854960"/>
                <a:ext cx="1608480" cy="1355040"/>
              </a:xfrm>
              <a:custGeom>
                <a:avLst/>
                <a:gdLst/>
                <a:ahLst/>
                <a:rect l="l" t="t" r="r" b="b"/>
                <a:pathLst>
                  <a:path w="138" h="122">
                    <a:moveTo>
                      <a:pt x="0" y="122"/>
                    </a:moveTo>
                    <a:lnTo>
                      <a:pt x="46" y="120"/>
                    </a:lnTo>
                    <a:lnTo>
                      <a:pt x="92" y="119"/>
                    </a:lnTo>
                    <a:lnTo>
                      <a:pt x="138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4719960" y="6210360"/>
                <a:ext cx="144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4685400" y="6210360"/>
                <a:ext cx="813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 flipV="1">
                <a:off x="5256360" y="6154920"/>
                <a:ext cx="2160" cy="33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5221440" y="6154920"/>
                <a:ext cx="813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 flipV="1">
                <a:off x="5792400" y="6099120"/>
                <a:ext cx="2160" cy="77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600" bIns="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5757840" y="6099480"/>
                <a:ext cx="81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 flipV="1">
                <a:off x="6328800" y="4466160"/>
                <a:ext cx="2160" cy="38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6293880" y="4466520"/>
                <a:ext cx="813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4719960" y="6210360"/>
                <a:ext cx="144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4685400" y="6210360"/>
                <a:ext cx="813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5256360" y="6188040"/>
                <a:ext cx="2160" cy="44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5221440" y="6232680"/>
                <a:ext cx="813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5792400" y="6177240"/>
                <a:ext cx="2160" cy="88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120" bIns="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5757840" y="6266160"/>
                <a:ext cx="81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6328800" y="4854960"/>
                <a:ext cx="2160" cy="399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6293880" y="5255280"/>
                <a:ext cx="81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4719960" y="4677480"/>
                <a:ext cx="1608480" cy="1532520"/>
              </a:xfrm>
              <a:custGeom>
                <a:avLst/>
                <a:gdLst/>
                <a:ahLst/>
                <a:rect l="l" t="t" r="r" b="b"/>
                <a:pathLst>
                  <a:path w="138" h="138">
                    <a:moveTo>
                      <a:pt x="0" y="138"/>
                    </a:moveTo>
                    <a:lnTo>
                      <a:pt x="46" y="134"/>
                    </a:lnTo>
                    <a:lnTo>
                      <a:pt x="92" y="126"/>
                    </a:lnTo>
                    <a:lnTo>
                      <a:pt x="138" y="0"/>
                    </a:lnTo>
                  </a:path>
                </a:pathLst>
              </a:custGeom>
              <a:noFill/>
              <a:ln w="19080">
                <a:solidFill>
                  <a:srgbClr val="3366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4719960" y="6210360"/>
                <a:ext cx="144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4685400" y="6210360"/>
                <a:ext cx="813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 flipV="1">
                <a:off x="5256360" y="6054480"/>
                <a:ext cx="2160" cy="111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5221440" y="6054840"/>
                <a:ext cx="81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 flipV="1">
                <a:off x="5792400" y="5943600"/>
                <a:ext cx="2160" cy="133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5757840" y="5943600"/>
                <a:ext cx="813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 flipV="1">
                <a:off x="6328800" y="4477320"/>
                <a:ext cx="2160" cy="199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6293880" y="4477680"/>
                <a:ext cx="81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4719960" y="6210360"/>
                <a:ext cx="144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4685400" y="6210360"/>
                <a:ext cx="813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5256360" y="6166080"/>
                <a:ext cx="2160" cy="122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5221440" y="6288480"/>
                <a:ext cx="81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5792400" y="6077160"/>
                <a:ext cx="2160" cy="122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5757840" y="6199560"/>
                <a:ext cx="81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6328800" y="4677480"/>
                <a:ext cx="2160" cy="188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6293880" y="4866480"/>
                <a:ext cx="81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4673520" y="6166080"/>
                <a:ext cx="93240" cy="88560"/>
              </a:xfrm>
              <a:custGeom>
                <a:avLst/>
                <a:gdLst/>
                <a:ahLst/>
                <a:rect l="l" t="t" r="r" b="b"/>
                <a:pathLst>
                  <a:path w="48" h="48">
                    <a:moveTo>
                      <a:pt x="24" y="0"/>
                    </a:moveTo>
                    <a:lnTo>
                      <a:pt x="48" y="48"/>
                    </a:lnTo>
                    <a:lnTo>
                      <a:pt x="0" y="48"/>
                    </a:lnTo>
                    <a:lnTo>
                      <a:pt x="24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1760" bIns="41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5209560" y="6144120"/>
                <a:ext cx="93240" cy="88560"/>
              </a:xfrm>
              <a:custGeom>
                <a:avLst/>
                <a:gdLst/>
                <a:ahLst/>
                <a:rect l="l" t="t" r="r" b="b"/>
                <a:pathLst>
                  <a:path w="48" h="48">
                    <a:moveTo>
                      <a:pt x="24" y="0"/>
                    </a:moveTo>
                    <a:lnTo>
                      <a:pt x="48" y="48"/>
                    </a:lnTo>
                    <a:lnTo>
                      <a:pt x="0" y="48"/>
                    </a:lnTo>
                    <a:lnTo>
                      <a:pt x="24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1760" bIns="41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5745960" y="6132600"/>
                <a:ext cx="93240" cy="88920"/>
              </a:xfrm>
              <a:custGeom>
                <a:avLst/>
                <a:gdLst/>
                <a:ahLst/>
                <a:rect l="l" t="t" r="r" b="b"/>
                <a:pathLst>
                  <a:path w="48" h="48">
                    <a:moveTo>
                      <a:pt x="24" y="0"/>
                    </a:moveTo>
                    <a:lnTo>
                      <a:pt x="48" y="48"/>
                    </a:lnTo>
                    <a:lnTo>
                      <a:pt x="0" y="48"/>
                    </a:lnTo>
                    <a:lnTo>
                      <a:pt x="24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120" bIns="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6282000" y="4811040"/>
                <a:ext cx="93240" cy="88560"/>
              </a:xfrm>
              <a:custGeom>
                <a:avLst/>
                <a:gdLst/>
                <a:ahLst/>
                <a:rect l="l" t="t" r="r" b="b"/>
                <a:pathLst>
                  <a:path w="48" h="48">
                    <a:moveTo>
                      <a:pt x="24" y="0"/>
                    </a:moveTo>
                    <a:lnTo>
                      <a:pt x="48" y="48"/>
                    </a:lnTo>
                    <a:lnTo>
                      <a:pt x="0" y="48"/>
                    </a:lnTo>
                    <a:lnTo>
                      <a:pt x="24" y="0"/>
                    </a:lnTo>
                    <a:close/>
                  </a:path>
                </a:pathLst>
              </a:custGeom>
              <a:solidFill>
                <a:srgbClr val="000080"/>
              </a:solidFill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1760" bIns="41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4673520" y="6166080"/>
                <a:ext cx="81360" cy="77400"/>
              </a:xfrm>
              <a:prstGeom prst="rect">
                <a:avLst/>
              </a:prstGeom>
              <a:solidFill>
                <a:srgbClr val="3366ff"/>
              </a:solidFill>
              <a:ln w="9360">
                <a:solidFill>
                  <a:srgbClr val="3366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600" bIns="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5209560" y="6121800"/>
                <a:ext cx="81360" cy="77400"/>
              </a:xfrm>
              <a:prstGeom prst="rect">
                <a:avLst/>
              </a:prstGeom>
              <a:solidFill>
                <a:srgbClr val="3366ff"/>
              </a:solidFill>
              <a:ln w="9360">
                <a:solidFill>
                  <a:srgbClr val="3366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600" bIns="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5745960" y="6032880"/>
                <a:ext cx="81720" cy="77400"/>
              </a:xfrm>
              <a:prstGeom prst="rect">
                <a:avLst/>
              </a:prstGeom>
              <a:solidFill>
                <a:srgbClr val="3366ff"/>
              </a:solidFill>
              <a:ln w="9360">
                <a:solidFill>
                  <a:srgbClr val="3366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600" bIns="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6282000" y="4633200"/>
                <a:ext cx="81720" cy="77760"/>
              </a:xfrm>
              <a:prstGeom prst="rect">
                <a:avLst/>
              </a:prstGeom>
              <a:solidFill>
                <a:srgbClr val="3366ff"/>
              </a:solidFill>
              <a:ln w="9360">
                <a:solidFill>
                  <a:srgbClr val="3366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8" name=""/>
            <p:cNvSpPr/>
            <p:nvPr/>
          </p:nvSpPr>
          <p:spPr>
            <a:xfrm>
              <a:off x="4275360" y="6283080"/>
              <a:ext cx="72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????"/>
                  <a:ea typeface="宋体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4275360" y="5571000"/>
              <a:ext cx="72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????"/>
                  <a:ea typeface="宋体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4275360" y="4850640"/>
              <a:ext cx="72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????"/>
                  <a:ea typeface="宋体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4275360" y="4140360"/>
              <a:ext cx="72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????"/>
                  <a:ea typeface="宋体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4704840" y="6411600"/>
              <a:ext cx="72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????"/>
                  <a:ea typeface="宋体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5241600" y="6411600"/>
              <a:ext cx="72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????"/>
                  <a:ea typeface="宋体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5776920" y="6411600"/>
              <a:ext cx="72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????"/>
                  <a:ea typeface="宋体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6313680" y="6411600"/>
              <a:ext cx="72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????"/>
                  <a:ea typeface="宋体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5357160" y="6650640"/>
              <a:ext cx="290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ay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 rot="16200000">
              <a:off x="3307680" y="5380200"/>
              <a:ext cx="1404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ell number (x 10 </a:t>
              </a:r>
              <a:r>
                <a:rPr b="0" lang="en-CA" sz="1000" spc="-1" strike="noStrike" baseline="30000">
                  <a:solidFill>
                    <a:srgbClr val="000000"/>
                  </a:solidFill>
                  <a:latin typeface="Arial"/>
                  <a:ea typeface="宋体"/>
                </a:rPr>
                <a:t>6</a:t>
              </a:r>
              <a:r>
                <a:rPr b="0" lang="en-CA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cells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8" name=""/>
            <p:cNvGrpSpPr/>
            <p:nvPr/>
          </p:nvGrpSpPr>
          <p:grpSpPr>
            <a:xfrm>
              <a:off x="4885560" y="4412160"/>
              <a:ext cx="644400" cy="432720"/>
              <a:chOff x="4885560" y="4412160"/>
              <a:chExt cx="644400" cy="432720"/>
            </a:xfrm>
          </p:grpSpPr>
          <p:sp>
            <p:nvSpPr>
              <p:cNvPr id="109" name=""/>
              <p:cNvSpPr/>
              <p:nvPr/>
            </p:nvSpPr>
            <p:spPr>
              <a:xfrm>
                <a:off x="4885560" y="4453560"/>
                <a:ext cx="101880" cy="93240"/>
              </a:xfrm>
              <a:prstGeom prst="rect">
                <a:avLst/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440" bIns="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5054400" y="4412160"/>
                <a:ext cx="261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GFP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4885560" y="4751640"/>
                <a:ext cx="101880" cy="932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440" bIns="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4885560" y="4751640"/>
                <a:ext cx="101880" cy="93240"/>
              </a:xfrm>
              <a:prstGeom prst="rect">
                <a:avLst/>
              </a:prstGeom>
              <a:blipFill rotWithShape="0">
                <a:blip r:embed="rId1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440" bIns="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5052240" y="4692240"/>
                <a:ext cx="4777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miR-32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14" name=""/>
          <p:cNvSpPr/>
          <p:nvPr/>
        </p:nvSpPr>
        <p:spPr>
          <a:xfrm>
            <a:off x="979560" y="3733920"/>
            <a:ext cx="1038240" cy="24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-Growth Facto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2188440" y="3733920"/>
            <a:ext cx="1068480" cy="24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+Growth Facto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307080" y="4497480"/>
            <a:ext cx="452880" cy="24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GF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117720" y="5742000"/>
            <a:ext cx="669240" cy="24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mi</a:t>
            </a:r>
            <a:r>
              <a:rPr b="0" lang="en-CA" sz="1000" spc="-1" strike="noStrike">
                <a:solidFill>
                  <a:srgbClr val="000000"/>
                </a:solidFill>
                <a:latin typeface="Arial"/>
                <a:ea typeface="宋体"/>
              </a:rPr>
              <a:t>R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-32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8" name="" descr=""/>
          <p:cNvPicPr/>
          <p:nvPr/>
        </p:nvPicPr>
        <p:blipFill>
          <a:blip r:embed="rId2"/>
          <a:stretch/>
        </p:blipFill>
        <p:spPr>
          <a:xfrm>
            <a:off x="700200" y="4002120"/>
            <a:ext cx="2946240" cy="2592360"/>
          </a:xfrm>
          <a:prstGeom prst="rect">
            <a:avLst/>
          </a:prstGeom>
          <a:ln w="0">
            <a:noFill/>
          </a:ln>
        </p:spPr>
      </p:pic>
      <p:grpSp>
        <p:nvGrpSpPr>
          <p:cNvPr id="119" name=""/>
          <p:cNvGrpSpPr/>
          <p:nvPr/>
        </p:nvGrpSpPr>
        <p:grpSpPr>
          <a:xfrm>
            <a:off x="563400" y="679320"/>
            <a:ext cx="2939760" cy="2741040"/>
            <a:chOff x="563400" y="679320"/>
            <a:chExt cx="2939760" cy="2741040"/>
          </a:xfrm>
        </p:grpSpPr>
        <p:sp>
          <p:nvSpPr>
            <p:cNvPr id="120" name=""/>
            <p:cNvSpPr/>
            <p:nvPr/>
          </p:nvSpPr>
          <p:spPr>
            <a:xfrm>
              <a:off x="1179720" y="3160080"/>
              <a:ext cx="361440" cy="248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5760" rIns="95760" tIns="47880" bIns="47880" anchor="t">
              <a:spAutoFit/>
            </a:bodyPr>
            <a:p>
              <a:pPr>
                <a:tabLst>
                  <a:tab algn="l" pos="0"/>
                  <a:tab algn="l" pos="957240"/>
                  <a:tab algn="l" pos="1914480"/>
                  <a:tab algn="l" pos="2871720"/>
                  <a:tab algn="l" pos="3828960"/>
                  <a:tab algn="l" pos="4786200"/>
                  <a:tab algn="l" pos="5743440"/>
                  <a:tab algn="l" pos="6700680"/>
                  <a:tab algn="l" pos="7658280"/>
                  <a:tab algn="l" pos="8615520"/>
                  <a:tab algn="l" pos="9572760"/>
                  <a:tab algn="l" pos="10530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1273680" y="1187640"/>
              <a:ext cx="141120" cy="1948680"/>
            </a:xfrm>
            <a:prstGeom prst="rect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1901160" y="1153800"/>
              <a:ext cx="141120" cy="1982520"/>
            </a:xfrm>
            <a:prstGeom prst="rect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2516760" y="1821960"/>
              <a:ext cx="140760" cy="1314360"/>
            </a:xfrm>
            <a:prstGeom prst="rect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3144240" y="2026440"/>
              <a:ext cx="141120" cy="1109880"/>
            </a:xfrm>
            <a:prstGeom prst="rect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1415160" y="2411640"/>
              <a:ext cx="142560" cy="72468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1415160" y="2411640"/>
              <a:ext cx="142560" cy="724680"/>
            </a:xfrm>
            <a:prstGeom prst="rect">
              <a:avLst/>
            </a:prstGeom>
            <a:blipFill rotWithShape="0">
              <a:blip r:embed="rId3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2042280" y="1992600"/>
              <a:ext cx="130320" cy="11437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2042280" y="1992600"/>
              <a:ext cx="130320" cy="1143720"/>
            </a:xfrm>
            <a:prstGeom prst="rect">
              <a:avLst/>
            </a:prstGeom>
            <a:blipFill rotWithShape="0">
              <a:blip r:embed="rId4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2657520" y="1448280"/>
              <a:ext cx="142920" cy="1688040"/>
            </a:xfrm>
            <a:prstGeom prst="rect">
              <a:avLst/>
            </a:prstGeom>
            <a:blipFill rotWithShape="0">
              <a:blip r:embed="rId5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2657520" y="1448280"/>
              <a:ext cx="142920" cy="16880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3285360" y="2502000"/>
              <a:ext cx="130320" cy="634320"/>
            </a:xfrm>
            <a:prstGeom prst="rect">
              <a:avLst/>
            </a:prstGeom>
            <a:blipFill rotWithShape="0">
              <a:blip r:embed="rId6"/>
              <a:srcRect/>
              <a:tile tx="0" ty="0" sx="100000" sy="100000" algn="ctr"/>
            </a:blip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3285360" y="2502000"/>
              <a:ext cx="130320" cy="6343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 flipV="1">
              <a:off x="1344240" y="848160"/>
              <a:ext cx="1080" cy="33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1308960" y="848160"/>
              <a:ext cx="828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 flipV="1">
              <a:off x="1971720" y="916200"/>
              <a:ext cx="1440" cy="23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1936800" y="916560"/>
              <a:ext cx="8280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 flipV="1">
              <a:off x="2587320" y="1426320"/>
              <a:ext cx="1080" cy="395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2552040" y="1426320"/>
              <a:ext cx="8280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 flipV="1">
              <a:off x="3214800" y="1720800"/>
              <a:ext cx="1440" cy="30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3179520" y="1721160"/>
              <a:ext cx="8280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 flipV="1">
              <a:off x="1485360" y="2309040"/>
              <a:ext cx="2880" cy="101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1450080" y="2309400"/>
              <a:ext cx="828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 flipV="1">
              <a:off x="2102400" y="1821960"/>
              <a:ext cx="1440" cy="170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2067120" y="1821960"/>
              <a:ext cx="82800" cy="2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 flipV="1">
              <a:off x="2729880" y="1096920"/>
              <a:ext cx="1080" cy="351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2694600" y="1097280"/>
              <a:ext cx="8280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 flipV="1">
              <a:off x="3345120" y="2365920"/>
              <a:ext cx="1080" cy="136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3310200" y="2365920"/>
              <a:ext cx="82800" cy="2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1178280" y="689400"/>
              <a:ext cx="1440" cy="2446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1131120" y="3136680"/>
              <a:ext cx="9468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1131120" y="2728800"/>
              <a:ext cx="946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1131120" y="2321280"/>
              <a:ext cx="946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1131120" y="1913760"/>
              <a:ext cx="9468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1131120" y="1504800"/>
              <a:ext cx="94680" cy="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1131120" y="1097280"/>
              <a:ext cx="9468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1178280" y="3136680"/>
              <a:ext cx="2286360" cy="5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959040" y="3081600"/>
              <a:ext cx="72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????"/>
                  <a:ea typeface="宋体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887760" y="267408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????"/>
                  <a:ea typeface="宋体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887760" y="226512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????"/>
                  <a:ea typeface="宋体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887760" y="185616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????"/>
                  <a:ea typeface="宋体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887760" y="144720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????"/>
                  <a:ea typeface="宋体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887760" y="104076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????"/>
                  <a:ea typeface="宋体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1799640" y="3164760"/>
              <a:ext cx="367560" cy="248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5760" rIns="95760" tIns="47880" bIns="47880" anchor="t">
              <a:spAutoFit/>
            </a:bodyPr>
            <a:p>
              <a:pPr>
                <a:tabLst>
                  <a:tab algn="l" pos="0"/>
                  <a:tab algn="l" pos="957240"/>
                  <a:tab algn="l" pos="1914480"/>
                  <a:tab algn="l" pos="2871720"/>
                  <a:tab algn="l" pos="3828960"/>
                  <a:tab algn="l" pos="4786200"/>
                  <a:tab algn="l" pos="5743440"/>
                  <a:tab algn="l" pos="6700680"/>
                  <a:tab algn="l" pos="7658280"/>
                  <a:tab algn="l" pos="8615520"/>
                  <a:tab algn="l" pos="9572760"/>
                  <a:tab algn="l" pos="10530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H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2415240" y="3171960"/>
              <a:ext cx="353880" cy="248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5760" rIns="95760" tIns="47880" bIns="47880" anchor="t">
              <a:spAutoFit/>
            </a:bodyPr>
            <a:p>
              <a:pPr>
                <a:tabLst>
                  <a:tab algn="l" pos="0"/>
                  <a:tab algn="l" pos="957240"/>
                  <a:tab algn="l" pos="1914480"/>
                  <a:tab algn="l" pos="2871720"/>
                  <a:tab algn="l" pos="3828960"/>
                  <a:tab algn="l" pos="4786200"/>
                  <a:tab algn="l" pos="5743440"/>
                  <a:tab algn="l" pos="6700680"/>
                  <a:tab algn="l" pos="7658280"/>
                  <a:tab algn="l" pos="8615520"/>
                  <a:tab algn="l" pos="9572760"/>
                  <a:tab algn="l" pos="10530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L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3057120" y="3169080"/>
              <a:ext cx="388800" cy="248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5760" rIns="95760" tIns="47880" bIns="47880" anchor="t">
              <a:spAutoFit/>
            </a:bodyPr>
            <a:p>
              <a:pPr>
                <a:tabLst>
                  <a:tab algn="l" pos="0"/>
                  <a:tab algn="l" pos="957240"/>
                  <a:tab algn="l" pos="1914480"/>
                  <a:tab algn="l" pos="2871720"/>
                  <a:tab algn="l" pos="3828960"/>
                  <a:tab algn="l" pos="4786200"/>
                  <a:tab algn="l" pos="5743440"/>
                  <a:tab algn="l" pos="6700680"/>
                  <a:tab algn="l" pos="7658280"/>
                  <a:tab algn="l" pos="8615520"/>
                  <a:tab algn="l" pos="9572760"/>
                  <a:tab algn="l" pos="10530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rt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66" name=""/>
            <p:cNvGrpSpPr/>
            <p:nvPr/>
          </p:nvGrpSpPr>
          <p:grpSpPr>
            <a:xfrm>
              <a:off x="2895840" y="679320"/>
              <a:ext cx="607320" cy="376920"/>
              <a:chOff x="2895840" y="679320"/>
              <a:chExt cx="607320" cy="376920"/>
            </a:xfrm>
          </p:grpSpPr>
          <p:sp>
            <p:nvSpPr>
              <p:cNvPr id="167" name=""/>
              <p:cNvSpPr/>
              <p:nvPr/>
            </p:nvSpPr>
            <p:spPr>
              <a:xfrm>
                <a:off x="2895840" y="712440"/>
                <a:ext cx="74520" cy="74520"/>
              </a:xfrm>
              <a:prstGeom prst="rect">
                <a:avLst/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720" bIns="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3020040" y="679320"/>
                <a:ext cx="261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GFP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>
                <a:off x="2895840" y="951120"/>
                <a:ext cx="74520" cy="745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720" bIns="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>
                <a:off x="2895840" y="951120"/>
                <a:ext cx="74520" cy="74520"/>
              </a:xfrm>
              <a:prstGeom prst="rect">
                <a:avLst/>
              </a:prstGeom>
              <a:blipFill rotWithShape="0">
                <a:blip r:embed="rId7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720" bIns="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>
                <a:off x="3016440" y="903600"/>
                <a:ext cx="4867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000" spc="-1" strike="noStrike">
                    <a:solidFill>
                      <a:srgbClr val="000000"/>
                    </a:solidFill>
                    <a:latin typeface="????"/>
                    <a:ea typeface="宋体"/>
                  </a:rPr>
                  <a:t>miR-32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72" name=""/>
            <p:cNvSpPr/>
            <p:nvPr/>
          </p:nvSpPr>
          <p:spPr>
            <a:xfrm rot="16200000">
              <a:off x="144000" y="2130840"/>
              <a:ext cx="991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????"/>
                  <a:ea typeface="宋体"/>
                </a:rPr>
                <a:t>cell adhesion (%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3" name=""/>
          <p:cNvSpPr/>
          <p:nvPr/>
        </p:nvSpPr>
        <p:spPr>
          <a:xfrm>
            <a:off x="334800" y="53964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宋体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325440" y="367020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宋体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3862440" y="363528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宋体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5-08T15:44:55Z</dcterms:created>
  <dc:creator>B. Yang</dc:creator>
  <dc:description/>
  <dc:language>en-US</dc:language>
  <cp:lastModifiedBy>B. Yang</cp:lastModifiedBy>
  <dcterms:modified xsi:type="dcterms:W3CDTF">2008-05-08T15:47:33Z</dcterms:modified>
  <cp:revision>1</cp:revision>
  <dc:subject/>
  <dc:title>Slide 1</dc:title>
</cp:coreProperties>
</file>